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5" r:id="rId4"/>
    <p:sldId id="268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1146" y="36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wmf"/><Relationship Id="rId2" Type="http://schemas.openxmlformats.org/officeDocument/2006/relationships/image" Target="../media/image10.wmf"/><Relationship Id="rId1" Type="http://schemas.openxmlformats.org/officeDocument/2006/relationships/image" Target="../media/image9.wmf"/><Relationship Id="rId5" Type="http://schemas.openxmlformats.org/officeDocument/2006/relationships/image" Target="../media/image13.wmf"/><Relationship Id="rId4" Type="http://schemas.openxmlformats.org/officeDocument/2006/relationships/image" Target="../media/image12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164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826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33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87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485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750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710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346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154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518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26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D7C4E-A885-4662-A9DB-D455A16235B4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90393-5668-4ABE-A894-AF2404A85C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654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w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13.w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0.wmf"/><Relationship Id="rId11" Type="http://schemas.openxmlformats.org/officeDocument/2006/relationships/oleObject" Target="../embeddings/oleObject12.bin"/><Relationship Id="rId5" Type="http://schemas.openxmlformats.org/officeDocument/2006/relationships/oleObject" Target="../embeddings/oleObject9.bin"/><Relationship Id="rId10" Type="http://schemas.openxmlformats.org/officeDocument/2006/relationships/image" Target="../media/image12.wmf"/><Relationship Id="rId4" Type="http://schemas.openxmlformats.org/officeDocument/2006/relationships/image" Target="../media/image9.wmf"/><Relationship Id="rId9" Type="http://schemas.openxmlformats.org/officeDocument/2006/relationships/oleObject" Target="../embeddings/oleObject1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85800" y="707410"/>
            <a:ext cx="5562600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plet excited carbonyls and singlet oxygen formation during oxidative radical reaction in skin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kus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asad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stasii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lukov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avel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píši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  <a:p>
            <a:pPr algn="ctr"/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Biophysics, Centre of the Regio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ná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Biotechnological and Agricultural Research, Faculty of Science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lacký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University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Šlechtitelů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7, 783 71 Olomouc, Czech Republi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ctr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7558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2379452" y="249996"/>
            <a:ext cx="144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r>
              <a:rPr lang="en-US" sz="1200" dirty="0" err="1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2274891"/>
              </p:ext>
            </p:extLst>
          </p:nvPr>
        </p:nvGraphicFramePr>
        <p:xfrm>
          <a:off x="76200" y="95488"/>
          <a:ext cx="3428272" cy="24060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4" r:id="rId3" imgW="5253840" imgH="3688200" progId="">
                  <p:embed/>
                </p:oleObj>
              </mc:Choice>
              <mc:Fallback>
                <p:oleObj r:id="rId3" imgW="5253840" imgH="36882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6200" y="95488"/>
                        <a:ext cx="3428272" cy="24060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9947398"/>
              </p:ext>
            </p:extLst>
          </p:nvPr>
        </p:nvGraphicFramePr>
        <p:xfrm>
          <a:off x="3359992" y="144748"/>
          <a:ext cx="3363873" cy="23567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5" r:id="rId5" imgW="5253840" imgH="3681000" progId="">
                  <p:embed/>
                </p:oleObj>
              </mc:Choice>
              <mc:Fallback>
                <p:oleObj r:id="rId5" imgW="5253840" imgH="3681000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59992" y="144748"/>
                        <a:ext cx="3363873" cy="235674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5579852" y="284500"/>
            <a:ext cx="144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6653922"/>
              </p:ext>
            </p:extLst>
          </p:nvPr>
        </p:nvGraphicFramePr>
        <p:xfrm>
          <a:off x="76200" y="2229088"/>
          <a:ext cx="3459090" cy="24401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6" r:id="rId7" imgW="5244084" imgH="3699510" progId="">
                  <p:embed/>
                </p:oleObj>
              </mc:Choice>
              <mc:Fallback>
                <p:oleObj r:id="rId7" imgW="5244084" imgH="3699510" progId="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6200" y="2229088"/>
                        <a:ext cx="3459090" cy="244010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4734471"/>
              </p:ext>
            </p:extLst>
          </p:nvPr>
        </p:nvGraphicFramePr>
        <p:xfrm>
          <a:off x="3344174" y="2260318"/>
          <a:ext cx="3429000" cy="24137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7" r:id="rId9" imgW="5254752" imgH="3699510" progId="">
                  <p:embed/>
                </p:oleObj>
              </mc:Choice>
              <mc:Fallback>
                <p:oleObj r:id="rId9" imgW="5254752" imgH="3699510" progId="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44174" y="2260318"/>
                        <a:ext cx="3429000" cy="241376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Rectangle 10"/>
          <p:cNvSpPr/>
          <p:nvPr/>
        </p:nvSpPr>
        <p:spPr>
          <a:xfrm>
            <a:off x="2370826" y="2410509"/>
            <a:ext cx="144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5571226" y="2372344"/>
            <a:ext cx="144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7758385"/>
              </p:ext>
            </p:extLst>
          </p:nvPr>
        </p:nvGraphicFramePr>
        <p:xfrm>
          <a:off x="0" y="4343400"/>
          <a:ext cx="3686247" cy="25870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8" r:id="rId11" imgW="5253840" imgH="3688200" progId="">
                  <p:embed/>
                </p:oleObj>
              </mc:Choice>
              <mc:Fallback>
                <p:oleObj r:id="rId11" imgW="5253840" imgH="3688200" progId="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0" y="4343400"/>
                        <a:ext cx="3686247" cy="258705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tangle 13"/>
          <p:cNvSpPr/>
          <p:nvPr/>
        </p:nvSpPr>
        <p:spPr>
          <a:xfrm>
            <a:off x="2395270" y="4587025"/>
            <a:ext cx="144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1702837"/>
              </p:ext>
            </p:extLst>
          </p:nvPr>
        </p:nvGraphicFramePr>
        <p:xfrm>
          <a:off x="3338766" y="4436852"/>
          <a:ext cx="3534242" cy="24887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9" r:id="rId13" imgW="5249418" imgH="3694938" progId="">
                  <p:embed/>
                </p:oleObj>
              </mc:Choice>
              <mc:Fallback>
                <p:oleObj r:id="rId13" imgW="5249418" imgH="3694938" progId="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38766" y="4436852"/>
                        <a:ext cx="3534242" cy="248872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Rectangle 14"/>
          <p:cNvSpPr/>
          <p:nvPr/>
        </p:nvSpPr>
        <p:spPr>
          <a:xfrm>
            <a:off x="5589912" y="4569772"/>
            <a:ext cx="144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3169606"/>
              </p:ext>
            </p:extLst>
          </p:nvPr>
        </p:nvGraphicFramePr>
        <p:xfrm>
          <a:off x="0" y="6629400"/>
          <a:ext cx="3686426" cy="25893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20" r:id="rId15" imgW="5270400" imgH="3702600" progId="">
                  <p:embed/>
                </p:oleObj>
              </mc:Choice>
              <mc:Fallback>
                <p:oleObj r:id="rId15" imgW="5270400" imgH="3702600" progId="">
                  <p:embed/>
                  <p:pic>
                    <p:nvPicPr>
                      <p:cNvPr id="0" name="Object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0" y="6629400"/>
                        <a:ext cx="3686426" cy="25893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Rectangle 16"/>
          <p:cNvSpPr/>
          <p:nvPr/>
        </p:nvSpPr>
        <p:spPr>
          <a:xfrm>
            <a:off x="2530418" y="6823496"/>
            <a:ext cx="1447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3614470" y="7086600"/>
            <a:ext cx="32766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: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ltra-weak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n emission measured using visibl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tomultiplier tube (PMT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etics of ultra-weak photon emission was measured in the presence of variable concentration of Fenton’s reagen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µM-1mM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s indicated) containing 500µM FeS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]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ed after ~2 min of the start of measurement (indicated by arrow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decay curve was measured for a duration of 30 min.</a:t>
            </a:r>
          </a:p>
          <a:p>
            <a:pPr algn="just"/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59479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1143000"/>
            <a:ext cx="4419600" cy="31145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Rectangle 8"/>
          <p:cNvSpPr/>
          <p:nvPr/>
        </p:nvSpPr>
        <p:spPr>
          <a:xfrm>
            <a:off x="0" y="4851737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: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ltra-weak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n emission measured using visibl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tomultiplier tube (PMT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etics of ultra-weak photon emission was measured in the presence of Fenton’s reagent (2mM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aining 500µM FeS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The decay curve was measured for a duration of 120 min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09751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7586008"/>
            <a:ext cx="68580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: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ltra-weak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n emission measured using visibl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tomultiplier tube (PMT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etics of ultra-weak photon emission was measured in dark (A); in the presence of Fenton’s reagent (100µM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aining 500µM FeS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(B); in the presence of Fenton’s reagent (1mM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aining 500 µM FeS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in the presence Fenton’s reagent (1mM H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aining 500µM FeS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containing 5mM sodiu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corbat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decay curve was measured for a duration of 10 min. The presented data are expressed as mean value of photon emission and the standard deviation of at least three measurements (mean ± SD, n=3) (E). </a:t>
            </a:r>
          </a:p>
          <a:p>
            <a:pPr algn="just"/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1609469"/>
              </p:ext>
            </p:extLst>
          </p:nvPr>
        </p:nvGraphicFramePr>
        <p:xfrm>
          <a:off x="0" y="5277851"/>
          <a:ext cx="3429000" cy="22762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2" r:id="rId3" imgW="4845558" imgH="3217164" progId="">
                  <p:embed/>
                </p:oleObj>
              </mc:Choice>
              <mc:Fallback>
                <p:oleObj r:id="rId3" imgW="4845558" imgH="3217164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0" y="5277851"/>
                        <a:ext cx="3429000" cy="227625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Rectangle 15"/>
          <p:cNvSpPr/>
          <p:nvPr/>
        </p:nvSpPr>
        <p:spPr>
          <a:xfrm>
            <a:off x="560687" y="5476340"/>
            <a:ext cx="5334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09600" y="849358"/>
            <a:ext cx="5334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3886200" y="907208"/>
            <a:ext cx="5334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567904" y="3228636"/>
            <a:ext cx="5334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3886200" y="3140018"/>
            <a:ext cx="5334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6708063"/>
              </p:ext>
            </p:extLst>
          </p:nvPr>
        </p:nvGraphicFramePr>
        <p:xfrm>
          <a:off x="-1896" y="698392"/>
          <a:ext cx="3479567" cy="2466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3" r:id="rId5" imgW="5212800" imgH="3695400" progId="">
                  <p:embed/>
                </p:oleObj>
              </mc:Choice>
              <mc:Fallback>
                <p:oleObj r:id="rId5" imgW="5212800" imgH="369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1896" y="698392"/>
                        <a:ext cx="3479567" cy="2466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9967255"/>
              </p:ext>
            </p:extLst>
          </p:nvPr>
        </p:nvGraphicFramePr>
        <p:xfrm>
          <a:off x="8624" y="3048000"/>
          <a:ext cx="3472499" cy="24729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4" r:id="rId7" imgW="5178600" imgH="3688200" progId="">
                  <p:embed/>
                </p:oleObj>
              </mc:Choice>
              <mc:Fallback>
                <p:oleObj r:id="rId7" imgW="5178600" imgH="36882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624" y="3048000"/>
                        <a:ext cx="3472499" cy="24729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5679064"/>
              </p:ext>
            </p:extLst>
          </p:nvPr>
        </p:nvGraphicFramePr>
        <p:xfrm>
          <a:off x="3298820" y="2963174"/>
          <a:ext cx="3580446" cy="25807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5" r:id="rId9" imgW="5162400" imgH="3720600" progId="">
                  <p:embed/>
                </p:oleObj>
              </mc:Choice>
              <mc:Fallback>
                <p:oleObj r:id="rId9" imgW="5162400" imgH="37206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298820" y="2963174"/>
                        <a:ext cx="3580446" cy="25807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8069184"/>
              </p:ext>
            </p:extLst>
          </p:nvPr>
        </p:nvGraphicFramePr>
        <p:xfrm>
          <a:off x="3352800" y="685800"/>
          <a:ext cx="3501454" cy="25011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6" r:id="rId11" imgW="5162400" imgH="3688200" progId="">
                  <p:embed/>
                </p:oleObj>
              </mc:Choice>
              <mc:Fallback>
                <p:oleObj r:id="rId11" imgW="5162400" imgH="36882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52800" y="685800"/>
                        <a:ext cx="3501454" cy="25011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77090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6</TotalTime>
  <Words>318</Words>
  <Application>Microsoft Office PowerPoint</Application>
  <PresentationFormat>On-screen Show (4:3)</PresentationFormat>
  <Paragraphs>54</Paragraphs>
  <Slides>4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kush Prasad, Ph.D.</dc:creator>
  <cp:lastModifiedBy>Ankush Prasad, Ph.D.</cp:lastModifiedBy>
  <cp:revision>48</cp:revision>
  <dcterms:created xsi:type="dcterms:W3CDTF">2018-04-13T10:05:48Z</dcterms:created>
  <dcterms:modified xsi:type="dcterms:W3CDTF">2018-08-01T08:19:48Z</dcterms:modified>
</cp:coreProperties>
</file>